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62" autoAdjust="0"/>
    <p:restoredTop sz="94660"/>
  </p:normalViewPr>
  <p:slideViewPr>
    <p:cSldViewPr snapToGrid="0">
      <p:cViewPr varScale="1">
        <p:scale>
          <a:sx n="71" d="100"/>
          <a:sy n="71" d="100"/>
        </p:scale>
        <p:origin x="110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2488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7666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1704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4734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338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6725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058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6553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5935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7284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76589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066EE-675B-4334-A0CF-8E43F2181E89}" type="datetimeFigureOut">
              <a:rPr kumimoji="1" lang="ja-JP" altLang="en-US" smtClean="0"/>
              <a:t>2022/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DA52F-C9CE-4BDC-8878-0A4205ACB2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302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24889" y="0"/>
            <a:ext cx="5791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l Table 1. Subject summary used in this study</a:t>
            </a:r>
            <a:endParaRPr kumimoji="1" lang="ja-JP" altLang="en-US" sz="12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9567466"/>
              </p:ext>
            </p:extLst>
          </p:nvPr>
        </p:nvGraphicFramePr>
        <p:xfrm>
          <a:off x="458040" y="621692"/>
          <a:ext cx="5915028" cy="1951134"/>
        </p:xfrm>
        <a:graphic>
          <a:graphicData uri="http://schemas.openxmlformats.org/drawingml/2006/table">
            <a:tbl>
              <a:tblPr/>
              <a:tblGrid>
                <a:gridCol w="492919">
                  <a:extLst>
                    <a:ext uri="{9D8B030D-6E8A-4147-A177-3AD203B41FA5}">
                      <a16:colId xmlns:a16="http://schemas.microsoft.com/office/drawing/2014/main" val="3669521104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1870361003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392459000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1813689067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3506631141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3344809228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3358819679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4114356151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715631516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76159196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3039172926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358356393"/>
                    </a:ext>
                  </a:extLst>
                </a:gridCol>
              </a:tblGrid>
              <a:tr h="13692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11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chick #s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6467940"/>
                  </a:ext>
                </a:extLst>
              </a:tr>
              <a:tr h="13692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1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2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3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4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5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6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7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8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9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10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#11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2281787"/>
                  </a:ext>
                </a:extLst>
              </a:tr>
              <a:tr h="136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probes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1321401"/>
                  </a:ext>
                </a:extLst>
              </a:tr>
              <a:tr h="1711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5-HTR1B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5527570"/>
                  </a:ext>
                </a:extLst>
              </a:tr>
              <a:tr h="1711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5-HTR1D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2550098"/>
                  </a:ext>
                </a:extLst>
              </a:tr>
              <a:tr h="1711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5-HTR1E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1349300"/>
                  </a:ext>
                </a:extLst>
              </a:tr>
              <a:tr h="1711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5-HTR1F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09105"/>
                  </a:ext>
                </a:extLst>
              </a:tr>
              <a:tr h="1711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5-HTR2B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4818321"/>
                  </a:ext>
                </a:extLst>
              </a:tr>
              <a:tr h="1711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5-HTR3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5301324"/>
                  </a:ext>
                </a:extLst>
              </a:tr>
              <a:tr h="1711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5-HTR5A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1245997"/>
                  </a:ext>
                </a:extLst>
              </a:tr>
              <a:tr h="1711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5-HTR7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8130681"/>
                  </a:ext>
                </a:extLst>
              </a:tr>
              <a:tr h="1711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LEF1</a:t>
                      </a:r>
                    </a:p>
                  </a:txBody>
                  <a:tcPr marL="6846" marR="6846" marT="68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○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6846" marR="6846" marT="684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78919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28672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4889" y="0"/>
            <a:ext cx="5791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l Table </a:t>
            </a:r>
            <a:r>
              <a:rPr lang="en-US" altLang="ja-JP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2. </a:t>
            </a:r>
            <a:r>
              <a:rPr lang="en-US" altLang="ja-JP" sz="12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Overview </a:t>
            </a:r>
            <a:r>
              <a:rPr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of RNA probes used in this study</a:t>
            </a:r>
            <a:endParaRPr kumimoji="1" lang="ja-JP" altLang="en-US" sz="12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2941122"/>
              </p:ext>
            </p:extLst>
          </p:nvPr>
        </p:nvGraphicFramePr>
        <p:xfrm>
          <a:off x="780539" y="625652"/>
          <a:ext cx="5346700" cy="3529965"/>
        </p:xfrm>
        <a:graphic>
          <a:graphicData uri="http://schemas.openxmlformats.org/drawingml/2006/table">
            <a:tbl>
              <a:tblPr firstRow="1" firstCol="1" bandRow="1"/>
              <a:tblGrid>
                <a:gridCol w="1320800">
                  <a:extLst>
                    <a:ext uri="{9D8B030D-6E8A-4147-A177-3AD203B41FA5}">
                      <a16:colId xmlns:a16="http://schemas.microsoft.com/office/drawing/2014/main" val="3111154417"/>
                    </a:ext>
                  </a:extLst>
                </a:gridCol>
                <a:gridCol w="939800">
                  <a:extLst>
                    <a:ext uri="{9D8B030D-6E8A-4147-A177-3AD203B41FA5}">
                      <a16:colId xmlns:a16="http://schemas.microsoft.com/office/drawing/2014/main" val="1115156824"/>
                    </a:ext>
                  </a:extLst>
                </a:gridCol>
                <a:gridCol w="1803400">
                  <a:extLst>
                    <a:ext uri="{9D8B030D-6E8A-4147-A177-3AD203B41FA5}">
                      <a16:colId xmlns:a16="http://schemas.microsoft.com/office/drawing/2014/main" val="3987851264"/>
                    </a:ext>
                  </a:extLst>
                </a:gridCol>
                <a:gridCol w="1282700">
                  <a:extLst>
                    <a:ext uri="{9D8B030D-6E8A-4147-A177-3AD203B41FA5}">
                      <a16:colId xmlns:a16="http://schemas.microsoft.com/office/drawing/2014/main" val="4161689997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Accession number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Gene symbol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Molecular characteristics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Probe preparation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8307545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XM_015284634.2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5-HTR1B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GPCR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ujita, </a:t>
                      </a: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et al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. (2020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1618434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XM_015297583.1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5-HTR1D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GPCR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ujita, et al. (2022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959699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XM_015284709.2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5-HTR1E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GPCR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ujita, et al. (2022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264575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XM_004938334.3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5-HTR1F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GPCR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ujita, et al. (2022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4700105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XM_025153310.1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5-HTR2B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GPCR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ujita, et al. (2022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2964923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XM_004948063.3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5-HTR3A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ligand-gated ion channel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ujita, </a:t>
                      </a: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et al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. (2020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1827099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XM_425970.3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5-HTR5A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GPCR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ujita, et al. (2022)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601884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XM_015288394.2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5-HTR7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GPCR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Fujita, et al. (2022)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3804527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XM_015276135.2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i="1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LEF1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transcription factor</a:t>
                      </a:r>
                      <a:endParaRPr lang="ja-JP" sz="12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sz="12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5654477"/>
                  </a:ext>
                </a:extLst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670348" y="4273437"/>
            <a:ext cx="545689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5-HTR: 5-hydroxytriptamine receptor; GPCR: G protein-coupled receptor; LEF1: lymphoid enhancer factor 1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9839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77</Words>
  <Application>Microsoft Office PowerPoint</Application>
  <PresentationFormat>A4 210 x 297 mm</PresentationFormat>
  <Paragraphs>16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1" baseType="lpstr">
      <vt:lpstr>ＭＳ 明朝</vt:lpstr>
      <vt:lpstr>游ゴシック</vt:lpstr>
      <vt:lpstr>游ゴシック Light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. Fujita</dc:creator>
  <cp:lastModifiedBy>T. Fujita</cp:lastModifiedBy>
  <cp:revision>3</cp:revision>
  <dcterms:created xsi:type="dcterms:W3CDTF">2021-11-02T05:24:51Z</dcterms:created>
  <dcterms:modified xsi:type="dcterms:W3CDTF">2022-02-24T00:58:07Z</dcterms:modified>
</cp:coreProperties>
</file>